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2/04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20115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uccessful ABO and HLA incompatible kidney transplantation in children in the United Kingdom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0046" y="11938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Paediatric ABOi and HLAi kidney transplants have comparable longer-term outcomes with compatible transplant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ew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7541" y="5877143"/>
            <a:ext cx="72446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BOi and HLAi kidney transplantations are feasible, with good 10-year outcomes, where no compatible donors are available.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CF0D776C-89DF-D84F-A365-76EAA2483689}"/>
              </a:ext>
            </a:extLst>
          </p:cNvPr>
          <p:cNvSpPr/>
          <p:nvPr/>
        </p:nvSpPr>
        <p:spPr>
          <a:xfrm>
            <a:off x="767865" y="318525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A2FC4997-E4EA-E141-A3BE-FFB2E3BB175D}"/>
              </a:ext>
            </a:extLst>
          </p:cNvPr>
          <p:cNvSpPr/>
          <p:nvPr/>
        </p:nvSpPr>
        <p:spPr>
          <a:xfrm>
            <a:off x="1075762" y="327777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D5AF43-ABBE-F042-8C7F-726E429A980B}"/>
              </a:ext>
            </a:extLst>
          </p:cNvPr>
          <p:cNvSpPr/>
          <p:nvPr/>
        </p:nvSpPr>
        <p:spPr>
          <a:xfrm>
            <a:off x="1438490" y="318525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61D46751-9537-AD4C-9C0B-C4DDBC4047A7}"/>
              </a:ext>
            </a:extLst>
          </p:cNvPr>
          <p:cNvSpPr/>
          <p:nvPr/>
        </p:nvSpPr>
        <p:spPr>
          <a:xfrm>
            <a:off x="1738426" y="32531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6D2CD2E-CCDB-E24C-A0FD-20F4DA14535B}"/>
              </a:ext>
            </a:extLst>
          </p:cNvPr>
          <p:cNvSpPr/>
          <p:nvPr/>
        </p:nvSpPr>
        <p:spPr>
          <a:xfrm>
            <a:off x="467929" y="2405129"/>
            <a:ext cx="1941121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711 living donor kidney transplant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3F18AA6-45A6-AD4D-AECB-B42AAA667FA1}"/>
              </a:ext>
            </a:extLst>
          </p:cNvPr>
          <p:cNvSpPr txBox="1"/>
          <p:nvPr/>
        </p:nvSpPr>
        <p:spPr>
          <a:xfrm>
            <a:off x="328382" y="4482208"/>
            <a:ext cx="222021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Retrospective multicentre study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86E347B-971E-824E-823B-0000D21D3A87}"/>
              </a:ext>
            </a:extLst>
          </p:cNvPr>
          <p:cNvCxnSpPr/>
          <p:nvPr/>
        </p:nvCxnSpPr>
        <p:spPr>
          <a:xfrm flipV="1">
            <a:off x="2716947" y="2899970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FD7CDDD-FD8C-6A40-BE25-74ECA12236AE}"/>
              </a:ext>
            </a:extLst>
          </p:cNvPr>
          <p:cNvCxnSpPr/>
          <p:nvPr/>
        </p:nvCxnSpPr>
        <p:spPr>
          <a:xfrm flipV="1">
            <a:off x="2721601" y="3552755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11864F6-9495-A541-A4FE-5D0026FBE5BA}"/>
              </a:ext>
            </a:extLst>
          </p:cNvPr>
          <p:cNvCxnSpPr/>
          <p:nvPr/>
        </p:nvCxnSpPr>
        <p:spPr>
          <a:xfrm>
            <a:off x="2716947" y="3849285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CE450CAE-B7CC-6740-BE32-BB77A78F8AA9}"/>
              </a:ext>
            </a:extLst>
          </p:cNvPr>
          <p:cNvSpPr/>
          <p:nvPr/>
        </p:nvSpPr>
        <p:spPr>
          <a:xfrm>
            <a:off x="3553045" y="253340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3 ABOi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BBF63A4-539E-E645-8268-64B87B933286}"/>
              </a:ext>
            </a:extLst>
          </p:cNvPr>
          <p:cNvSpPr/>
          <p:nvPr/>
        </p:nvSpPr>
        <p:spPr>
          <a:xfrm>
            <a:off x="3553044" y="3263752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6 HLAi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EA27A41-4B3F-DA46-9AE9-56ABA645A918}"/>
              </a:ext>
            </a:extLst>
          </p:cNvPr>
          <p:cNvSpPr/>
          <p:nvPr/>
        </p:nvSpPr>
        <p:spPr>
          <a:xfrm>
            <a:off x="3553045" y="3987587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682 ABOc/HLAc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638AAB6-7232-B743-9D7A-67FB0F622053}"/>
              </a:ext>
            </a:extLst>
          </p:cNvPr>
          <p:cNvSpPr/>
          <p:nvPr/>
        </p:nvSpPr>
        <p:spPr>
          <a:xfrm>
            <a:off x="5454571" y="1758951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atient survival 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192DDDE-048D-054E-A218-4989CAE99281}"/>
              </a:ext>
            </a:extLst>
          </p:cNvPr>
          <p:cNvSpPr/>
          <p:nvPr/>
        </p:nvSpPr>
        <p:spPr>
          <a:xfrm>
            <a:off x="5454571" y="253340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87%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A8D8F93-035B-F94C-BC98-26E4D956BED5}"/>
              </a:ext>
            </a:extLst>
          </p:cNvPr>
          <p:cNvSpPr/>
          <p:nvPr/>
        </p:nvSpPr>
        <p:spPr>
          <a:xfrm>
            <a:off x="5461499" y="3260214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00 %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4784E19-97DD-524C-967F-EE20C9A17CAA}"/>
              </a:ext>
            </a:extLst>
          </p:cNvPr>
          <p:cNvSpPr/>
          <p:nvPr/>
        </p:nvSpPr>
        <p:spPr>
          <a:xfrm>
            <a:off x="5461499" y="3987586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96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FD449D2-520C-184B-A5A4-4D70A5FA2719}"/>
              </a:ext>
            </a:extLst>
          </p:cNvPr>
          <p:cNvSpPr txBox="1"/>
          <p:nvPr/>
        </p:nvSpPr>
        <p:spPr>
          <a:xfrm>
            <a:off x="2716947" y="4670118"/>
            <a:ext cx="5226150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Death censored renal allograft survival was 100% in all 3 groups at last follow-up</a:t>
            </a:r>
            <a:r>
              <a:rPr lang="en-GB" sz="2000" dirty="0">
                <a:solidFill>
                  <a:srgbClr val="296DC0"/>
                </a:solidFill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FC26BE8-1C91-0344-985A-EB4C1CD49D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09" t="10139" r="4306" b="4418"/>
          <a:stretch/>
        </p:blipFill>
        <p:spPr>
          <a:xfrm>
            <a:off x="7294062" y="1785337"/>
            <a:ext cx="4850557" cy="2920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6</cp:revision>
  <dcterms:created xsi:type="dcterms:W3CDTF">2019-06-13T12:30:18Z</dcterms:created>
  <dcterms:modified xsi:type="dcterms:W3CDTF">2022-04-12T19:24:39Z</dcterms:modified>
</cp:coreProperties>
</file>